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5.jpeg" ContentType="image/jpe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media/image8.png" ContentType="image/png"/>
  <Override PartName="/ppt/media/image9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6C9FDE-5855-4787-ACFE-70291183BB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C105F-02A4-4396-A3BD-1FBE563BA8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D99A8-0AA7-4BEB-992B-950CFBC684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0F9EE-1DEE-4F7D-966B-5D232652F0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1C7A4-17F7-4953-ACB6-0B210FC257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50176A-7FC2-4B08-A698-387A66D9C8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7C061-1DFB-4115-AF0C-98D8E43FC4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00199-D159-4758-B97A-72D7F15050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DA69F-9ECE-40FE-8896-091B3F770E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460B2-B46B-4E49-B377-BABE830E63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7B4FD-BDF1-4D14-BEAC-CF42A613A8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74894-4CE5-4A79-878D-FDAACDC8D2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5C75B6-EDE2-4FB8-9A4F-57FA56479D4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jpe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0"/>
          <p:cNvSpPr/>
          <p:nvPr/>
        </p:nvSpPr>
        <p:spPr>
          <a:xfrm>
            <a:off x="528480" y="609480"/>
            <a:ext cx="628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M-H2DCFDA             Phase                  CM-H2DCFDA             Phase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3"/>
          <p:cNvSpPr/>
          <p:nvPr/>
        </p:nvSpPr>
        <p:spPr>
          <a:xfrm rot="16200000">
            <a:off x="3276000" y="1202040"/>
            <a:ext cx="5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3"/>
          <p:cNvSpPr/>
          <p:nvPr/>
        </p:nvSpPr>
        <p:spPr>
          <a:xfrm rot="16200000">
            <a:off x="-67680" y="1339200"/>
            <a:ext cx="83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4"/>
          <p:cNvSpPr/>
          <p:nvPr/>
        </p:nvSpPr>
        <p:spPr>
          <a:xfrm rot="16200000">
            <a:off x="97200" y="2383920"/>
            <a:ext cx="490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3"/>
          <p:cNvSpPr/>
          <p:nvPr/>
        </p:nvSpPr>
        <p:spPr>
          <a:xfrm rot="16200000">
            <a:off x="27720" y="3399120"/>
            <a:ext cx="64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7"/>
          <p:cNvSpPr/>
          <p:nvPr/>
        </p:nvSpPr>
        <p:spPr>
          <a:xfrm>
            <a:off x="6056280" y="4237200"/>
            <a:ext cx="685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0X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3"/>
          <p:cNvSpPr/>
          <p:nvPr/>
        </p:nvSpPr>
        <p:spPr>
          <a:xfrm rot="16200000">
            <a:off x="3332520" y="2316960"/>
            <a:ext cx="50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76"/>
          <p:cNvSpPr/>
          <p:nvPr/>
        </p:nvSpPr>
        <p:spPr>
          <a:xfrm rot="16200000">
            <a:off x="-416160" y="5888520"/>
            <a:ext cx="181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ell numbers / HPF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3"/>
          <p:cNvSpPr/>
          <p:nvPr/>
        </p:nvSpPr>
        <p:spPr>
          <a:xfrm>
            <a:off x="71280" y="1429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標楷體"/>
              </a:rPr>
              <a:t>A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4"/>
          <p:cNvSpPr/>
          <p:nvPr/>
        </p:nvSpPr>
        <p:spPr>
          <a:xfrm>
            <a:off x="118800" y="44118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3"/>
          <p:cNvSpPr/>
          <p:nvPr/>
        </p:nvSpPr>
        <p:spPr>
          <a:xfrm rot="16200000">
            <a:off x="3312360" y="339912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8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oup 20"/>
          <p:cNvGrpSpPr/>
          <p:nvPr/>
        </p:nvGrpSpPr>
        <p:grpSpPr>
          <a:xfrm>
            <a:off x="2131920" y="7524720"/>
            <a:ext cx="4033440" cy="69840"/>
            <a:chOff x="2131920" y="7524720"/>
            <a:chExt cx="4033440" cy="69840"/>
          </a:xfrm>
        </p:grpSpPr>
        <p:sp>
          <p:nvSpPr>
            <p:cNvPr id="53" name="Line 21"/>
            <p:cNvSpPr/>
            <p:nvPr/>
          </p:nvSpPr>
          <p:spPr>
            <a:xfrm flipV="1">
              <a:off x="6165360" y="7524720"/>
              <a:ext cx="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22"/>
            <p:cNvSpPr/>
            <p:nvPr/>
          </p:nvSpPr>
          <p:spPr>
            <a:xfrm flipV="1">
              <a:off x="2133360" y="7524720"/>
              <a:ext cx="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3"/>
            <p:cNvSpPr/>
            <p:nvPr/>
          </p:nvSpPr>
          <p:spPr>
            <a:xfrm>
              <a:off x="2131920" y="7594560"/>
              <a:ext cx="4033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Text Box 25"/>
          <p:cNvSpPr/>
          <p:nvPr/>
        </p:nvSpPr>
        <p:spPr>
          <a:xfrm>
            <a:off x="1052640" y="7161120"/>
            <a:ext cx="5472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ontrol          1hr              2hr              4hr              6hr              8hr </a:t>
            </a:r>
            <a:endParaRPr b="1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6"/>
          <p:cNvSpPr/>
          <p:nvPr/>
        </p:nvSpPr>
        <p:spPr>
          <a:xfrm>
            <a:off x="2421000" y="8675640"/>
            <a:ext cx="237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ary Fig.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6"/>
          <p:cNvSpPr/>
          <p:nvPr/>
        </p:nvSpPr>
        <p:spPr>
          <a:xfrm>
            <a:off x="2060640" y="108000"/>
            <a:ext cx="259236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3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ree radical assay</a:t>
            </a:r>
            <a:endParaRPr b="1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6"/>
          <p:cNvSpPr/>
          <p:nvPr/>
        </p:nvSpPr>
        <p:spPr>
          <a:xfrm>
            <a:off x="3498840" y="7666200"/>
            <a:ext cx="137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BO  2.5 AT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0" name="Object 70"/>
          <p:cNvGraphicFramePr/>
          <p:nvPr/>
        </p:nvGraphicFramePr>
        <p:xfrm>
          <a:off x="500040" y="4786200"/>
          <a:ext cx="6048360" cy="2592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61" name="Object 7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00040" y="4786200"/>
                    <a:ext cx="6048360" cy="259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62" name="Picture 40" descr="DSC_0976-1hr(1)"/>
          <p:cNvPicPr/>
          <p:nvPr/>
        </p:nvPicPr>
        <p:blipFill>
          <a:blip r:embed="rId3"/>
          <a:stretch/>
        </p:blipFill>
        <p:spPr>
          <a:xfrm>
            <a:off x="2000160" y="3132000"/>
            <a:ext cx="1440000" cy="100836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46" descr="DSC_1027-2hr(1)"/>
          <p:cNvPicPr/>
          <p:nvPr/>
        </p:nvPicPr>
        <p:blipFill>
          <a:blip r:embed="rId4"/>
          <a:stretch/>
        </p:blipFill>
        <p:spPr>
          <a:xfrm>
            <a:off x="5229360" y="3132000"/>
            <a:ext cx="1439640" cy="100836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35" descr="DSC_0898--1--ctrl"/>
          <p:cNvPicPr/>
          <p:nvPr/>
        </p:nvPicPr>
        <p:blipFill>
          <a:blip r:embed="rId5"/>
          <a:stretch/>
        </p:blipFill>
        <p:spPr>
          <a:xfrm>
            <a:off x="476280" y="971640"/>
            <a:ext cx="1440000" cy="10080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36" descr="DSC_0899--1--ctrl"/>
          <p:cNvPicPr/>
          <p:nvPr/>
        </p:nvPicPr>
        <p:blipFill>
          <a:blip r:embed="rId6"/>
          <a:stretch/>
        </p:blipFill>
        <p:spPr>
          <a:xfrm>
            <a:off x="1989000" y="971640"/>
            <a:ext cx="1440000" cy="100800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37" descr="DSC_0999--1--1hr"/>
          <p:cNvPicPr/>
          <p:nvPr/>
        </p:nvPicPr>
        <p:blipFill>
          <a:blip r:embed="rId7"/>
          <a:stretch/>
        </p:blipFill>
        <p:spPr>
          <a:xfrm>
            <a:off x="476280" y="2050920"/>
            <a:ext cx="1440000" cy="100836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38" descr="DSC_1000--1-1hr"/>
          <p:cNvPicPr/>
          <p:nvPr/>
        </p:nvPicPr>
        <p:blipFill>
          <a:blip r:embed="rId8"/>
          <a:stretch/>
        </p:blipFill>
        <p:spPr>
          <a:xfrm>
            <a:off x="1989000" y="2050920"/>
            <a:ext cx="1440000" cy="100836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39" descr="DSC_0975-1hr(1)--1-2hr"/>
          <p:cNvPicPr/>
          <p:nvPr/>
        </p:nvPicPr>
        <p:blipFill>
          <a:blip r:embed="rId9"/>
          <a:stretch/>
        </p:blipFill>
        <p:spPr>
          <a:xfrm>
            <a:off x="476280" y="3132000"/>
            <a:ext cx="1440000" cy="100836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40" descr="DSC_0892-ctrl(1)--1--4hr"/>
          <p:cNvPicPr/>
          <p:nvPr/>
        </p:nvPicPr>
        <p:blipFill>
          <a:blip r:embed="rId10"/>
          <a:stretch/>
        </p:blipFill>
        <p:spPr>
          <a:xfrm>
            <a:off x="3718080" y="971640"/>
            <a:ext cx="1439640" cy="100800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41" descr="DSC_0893-ctrl(1)--1--4hr"/>
          <p:cNvPicPr/>
          <p:nvPr/>
        </p:nvPicPr>
        <p:blipFill>
          <a:blip r:embed="rId11"/>
          <a:stretch/>
        </p:blipFill>
        <p:spPr>
          <a:xfrm>
            <a:off x="5227560" y="971640"/>
            <a:ext cx="1441440" cy="10047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42" descr="DSC_0894--1--6"/>
          <p:cNvPicPr/>
          <p:nvPr/>
        </p:nvPicPr>
        <p:blipFill>
          <a:blip r:embed="rId12"/>
          <a:stretch/>
        </p:blipFill>
        <p:spPr>
          <a:xfrm>
            <a:off x="3716280" y="2050920"/>
            <a:ext cx="1440000" cy="10083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43" descr="DSC_0895--1--6hr"/>
          <p:cNvPicPr/>
          <p:nvPr/>
        </p:nvPicPr>
        <p:blipFill>
          <a:blip r:embed="rId13"/>
          <a:stretch/>
        </p:blipFill>
        <p:spPr>
          <a:xfrm>
            <a:off x="5229360" y="2050920"/>
            <a:ext cx="1439640" cy="10083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46" descr="DSC_1028-2hr(1)--2--8hr"/>
          <p:cNvPicPr/>
          <p:nvPr/>
        </p:nvPicPr>
        <p:blipFill>
          <a:blip r:embed="rId14">
            <a:lum contrast="20000"/>
          </a:blip>
          <a:stretch/>
        </p:blipFill>
        <p:spPr>
          <a:xfrm>
            <a:off x="3719520" y="3132000"/>
            <a:ext cx="1438200" cy="1006560"/>
          </a:xfrm>
          <a:prstGeom prst="rect">
            <a:avLst/>
          </a:prstGeom>
          <a:ln w="0">
            <a:noFill/>
          </a:ln>
        </p:spPr>
      </p:pic>
      <p:sp>
        <p:nvSpPr>
          <p:cNvPr id="74" name="Text Box 80"/>
          <p:cNvSpPr/>
          <p:nvPr/>
        </p:nvSpPr>
        <p:spPr>
          <a:xfrm>
            <a:off x="2986200" y="5435640"/>
            <a:ext cx="576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80"/>
          <p:cNvSpPr/>
          <p:nvPr/>
        </p:nvSpPr>
        <p:spPr>
          <a:xfrm>
            <a:off x="3878280" y="5143680"/>
            <a:ext cx="576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80"/>
          <p:cNvSpPr/>
          <p:nvPr/>
        </p:nvSpPr>
        <p:spPr>
          <a:xfrm>
            <a:off x="4786200" y="5214960"/>
            <a:ext cx="576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80"/>
          <p:cNvSpPr/>
          <p:nvPr/>
        </p:nvSpPr>
        <p:spPr>
          <a:xfrm>
            <a:off x="5678640" y="4929120"/>
            <a:ext cx="576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20T05:42:42Z</dcterms:created>
  <dc:creator>lab</dc:creator>
  <dc:description/>
  <dc:language>en-US</dc:language>
  <cp:lastModifiedBy> </cp:lastModifiedBy>
  <dcterms:modified xsi:type="dcterms:W3CDTF">2011-05-04T08:34:30Z</dcterms:modified>
  <cp:revision>387</cp:revision>
  <dc:subject/>
  <dc:title>PowerPoint 簡報</dc:title>
</cp:coreProperties>
</file>